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handoutMasterIdLst>
    <p:handoutMasterId r:id="rId5"/>
  </p:handoutMasterIdLst>
  <p:sldIdLst>
    <p:sldId id="308" r:id="rId2"/>
    <p:sldId id="309" r:id="rId3"/>
  </p:sldIdLst>
  <p:sldSz cx="6858000" cy="9906000" type="A4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602" autoAdjust="0"/>
    <p:restoredTop sz="94388" autoAdjust="0"/>
  </p:normalViewPr>
  <p:slideViewPr>
    <p:cSldViewPr>
      <p:cViewPr>
        <p:scale>
          <a:sx n="80" d="100"/>
          <a:sy n="80" d="100"/>
        </p:scale>
        <p:origin x="-2490" y="7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45005" cy="45005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27257D7-D7BE-4475-912D-A861A539B70E}" type="datetimeFigureOut">
              <a:rPr lang="it-IT" smtClean="0"/>
              <a:t>14/12/2015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B067331-E300-493D-B25C-E95C2384BC29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5194881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6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F4DDC09-3A55-4B16-AD34-7AD3F499AB41}" type="datetimeFigureOut">
              <a:rPr lang="it-IT" smtClean="0"/>
              <a:t>14/12/2015</a:t>
            </a:fld>
            <a:endParaRPr lang="it-IT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44538"/>
            <a:ext cx="25749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155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3" y="9428584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6" y="9428584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F1D5D10-F67F-430D-926A-A83F6D16763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108719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F1D5D10-F67F-430D-926A-A83F6D16763D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7283217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9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7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7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92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13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402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402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402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1.tiff"/><Relationship Id="rId18" Type="http://schemas.openxmlformats.org/officeDocument/2006/relationships/image" Target="../media/image16.tiff"/><Relationship Id="rId26" Type="http://schemas.openxmlformats.org/officeDocument/2006/relationships/image" Target="../media/image24.tiff"/><Relationship Id="rId21" Type="http://schemas.openxmlformats.org/officeDocument/2006/relationships/image" Target="../media/image19.tiff"/><Relationship Id="rId34" Type="http://schemas.openxmlformats.org/officeDocument/2006/relationships/image" Target="../media/image32.tiff"/><Relationship Id="rId7" Type="http://schemas.openxmlformats.org/officeDocument/2006/relationships/image" Target="../media/image5.tiff"/><Relationship Id="rId12" Type="http://schemas.openxmlformats.org/officeDocument/2006/relationships/image" Target="../media/image10.tiff"/><Relationship Id="rId17" Type="http://schemas.openxmlformats.org/officeDocument/2006/relationships/image" Target="../media/image15.tiff"/><Relationship Id="rId25" Type="http://schemas.openxmlformats.org/officeDocument/2006/relationships/image" Target="../media/image23.tiff"/><Relationship Id="rId33" Type="http://schemas.openxmlformats.org/officeDocument/2006/relationships/image" Target="../media/image31.tiff"/><Relationship Id="rId38" Type="http://schemas.openxmlformats.org/officeDocument/2006/relationships/image" Target="../media/image36.tif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tiff"/><Relationship Id="rId20" Type="http://schemas.openxmlformats.org/officeDocument/2006/relationships/image" Target="../media/image18.tiff"/><Relationship Id="rId29" Type="http://schemas.openxmlformats.org/officeDocument/2006/relationships/image" Target="../media/image27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24" Type="http://schemas.openxmlformats.org/officeDocument/2006/relationships/image" Target="../media/image22.tiff"/><Relationship Id="rId32" Type="http://schemas.openxmlformats.org/officeDocument/2006/relationships/image" Target="../media/image30.tiff"/><Relationship Id="rId37" Type="http://schemas.openxmlformats.org/officeDocument/2006/relationships/image" Target="../media/image35.tiff"/><Relationship Id="rId5" Type="http://schemas.openxmlformats.org/officeDocument/2006/relationships/image" Target="../media/image3.tiff"/><Relationship Id="rId15" Type="http://schemas.openxmlformats.org/officeDocument/2006/relationships/image" Target="../media/image13.tiff"/><Relationship Id="rId23" Type="http://schemas.openxmlformats.org/officeDocument/2006/relationships/image" Target="../media/image21.tiff"/><Relationship Id="rId28" Type="http://schemas.openxmlformats.org/officeDocument/2006/relationships/image" Target="../media/image26.tiff"/><Relationship Id="rId36" Type="http://schemas.openxmlformats.org/officeDocument/2006/relationships/image" Target="../media/image34.tiff"/><Relationship Id="rId10" Type="http://schemas.openxmlformats.org/officeDocument/2006/relationships/image" Target="../media/image8.tiff"/><Relationship Id="rId19" Type="http://schemas.openxmlformats.org/officeDocument/2006/relationships/image" Target="../media/image17.tiff"/><Relationship Id="rId31" Type="http://schemas.openxmlformats.org/officeDocument/2006/relationships/image" Target="../media/image29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Relationship Id="rId14" Type="http://schemas.openxmlformats.org/officeDocument/2006/relationships/image" Target="../media/image12.tiff"/><Relationship Id="rId22" Type="http://schemas.openxmlformats.org/officeDocument/2006/relationships/image" Target="../media/image20.tiff"/><Relationship Id="rId27" Type="http://schemas.openxmlformats.org/officeDocument/2006/relationships/image" Target="../media/image25.tiff"/><Relationship Id="rId30" Type="http://schemas.openxmlformats.org/officeDocument/2006/relationships/image" Target="../media/image28.tiff"/><Relationship Id="rId35" Type="http://schemas.openxmlformats.org/officeDocument/2006/relationships/image" Target="../media/image33.tiff"/><Relationship Id="rId8" Type="http://schemas.openxmlformats.org/officeDocument/2006/relationships/image" Target="../media/image6.tiff"/><Relationship Id="rId3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1" name="Connettore 1 35"/>
          <p:cNvCxnSpPr/>
          <p:nvPr/>
        </p:nvCxnSpPr>
        <p:spPr>
          <a:xfrm>
            <a:off x="1332091" y="1677616"/>
            <a:ext cx="100584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 Box 26"/>
          <p:cNvSpPr txBox="1">
            <a:spLocks noChangeArrowheads="1"/>
          </p:cNvSpPr>
          <p:nvPr/>
        </p:nvSpPr>
        <p:spPr bwMode="auto">
          <a:xfrm rot="16200000">
            <a:off x="166768" y="4806275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XAV939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 Box 26"/>
          <p:cNvSpPr txBox="1">
            <a:spLocks noChangeArrowheads="1"/>
          </p:cNvSpPr>
          <p:nvPr/>
        </p:nvSpPr>
        <p:spPr bwMode="auto">
          <a:xfrm rot="16200000">
            <a:off x="166768" y="7957829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JNJ-BJ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 Box 26"/>
          <p:cNvSpPr txBox="1">
            <a:spLocks noChangeArrowheads="1"/>
          </p:cNvSpPr>
          <p:nvPr/>
        </p:nvSpPr>
        <p:spPr bwMode="auto">
          <a:xfrm rot="16200000">
            <a:off x="773128" y="907472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Untreated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 Box 26"/>
          <p:cNvSpPr txBox="1">
            <a:spLocks noChangeArrowheads="1"/>
          </p:cNvSpPr>
          <p:nvPr/>
        </p:nvSpPr>
        <p:spPr bwMode="auto">
          <a:xfrm rot="16200000">
            <a:off x="589185" y="2359411"/>
            <a:ext cx="1125125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HGF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 Box 26"/>
          <p:cNvSpPr txBox="1">
            <a:spLocks noChangeArrowheads="1"/>
          </p:cNvSpPr>
          <p:nvPr/>
        </p:nvSpPr>
        <p:spPr bwMode="auto">
          <a:xfrm rot="16200000">
            <a:off x="166769" y="1584799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Left Brace 6"/>
          <p:cNvSpPr/>
          <p:nvPr/>
        </p:nvSpPr>
        <p:spPr>
          <a:xfrm>
            <a:off x="681841" y="197530"/>
            <a:ext cx="380229" cy="2998009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67" name="Left Brace 66"/>
          <p:cNvSpPr/>
          <p:nvPr/>
        </p:nvSpPr>
        <p:spPr>
          <a:xfrm>
            <a:off x="681841" y="3395493"/>
            <a:ext cx="380229" cy="2998009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68" name="Left Brace 67"/>
          <p:cNvSpPr/>
          <p:nvPr/>
        </p:nvSpPr>
        <p:spPr>
          <a:xfrm>
            <a:off x="681841" y="6545536"/>
            <a:ext cx="380229" cy="2998009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3" name="Text Box 26"/>
          <p:cNvSpPr txBox="1">
            <a:spLocks noChangeArrowheads="1"/>
          </p:cNvSpPr>
          <p:nvPr/>
        </p:nvSpPr>
        <p:spPr bwMode="auto">
          <a:xfrm>
            <a:off x="1627599" y="77981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APC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 Box 26"/>
          <p:cNvSpPr txBox="1">
            <a:spLocks noChangeArrowheads="1"/>
          </p:cNvSpPr>
          <p:nvPr/>
        </p:nvSpPr>
        <p:spPr bwMode="auto">
          <a:xfrm>
            <a:off x="3081114" y="77981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TNKS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150" name="Picture 54" descr="F:\Nuova cartella\Lab\IF da settembre 2013\131023_rabbitAPC+mouseTNKS_wound_2nd exp - 60 min STRANI\300dpi 4cm\APC rosso\1-DMSO 0 min_ProjMax001_ch00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95431" y="303751"/>
            <a:ext cx="1438275" cy="14382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51" name="Picture 55" descr="F:\Nuova cartella\Lab\IF da settembre 2013\131023_rabbitAPC+mouseTNKS_wound_2nd exp - 60 min STRANI\300dpi 4cm\APC rosso\2-JNJ272 0 min_ProjMax001_ch00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95431" y="3466808"/>
            <a:ext cx="1438275" cy="14382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52" name="Picture 56" descr="F:\Nuova cartella\Lab\IF da settembre 2013\131023_rabbitAPC+mouseTNKS_wound_2nd exp - 60 min STRANI\300dpi 4cm\APC rosso\3-JNJ928 0 min_ProjMax001_ch00.tif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95431" y="6619728"/>
            <a:ext cx="1438275" cy="14382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53" name="Picture 57" descr="F:\Nuova cartella\Lab\IF da settembre 2013\131023_rabbitAPC+mouseTNKS_wound_2nd exp - 60 min STRANI\300dpi 4cm\APC rosso\4-DMSO 15 min_ProjMax001_ch00.tif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1295431" y="1757264"/>
            <a:ext cx="1438275" cy="14382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54" name="Picture 58" descr="F:\Nuova cartella\Lab\IF da settembre 2013\131023_rabbitAPC+mouseTNKS_wound_2nd exp - 60 min STRANI\300dpi 4cm\APC rosso\5-JNJ272 15 min_ProjMax001_ch00.tif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0800000">
            <a:off x="1295431" y="4915975"/>
            <a:ext cx="1438275" cy="14382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55" name="Picture 59" descr="F:\Nuova cartella\Lab\IF da settembre 2013\131023_rabbitAPC+mouseTNKS_wound_2nd exp - 60 min STRANI\300dpi 4cm\APC rosso\6-JNJ928 15 min_ProjMax001_ch00.tif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95431" y="8073245"/>
            <a:ext cx="1438275" cy="14382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56" name="Picture 60" descr="F:\Nuova cartella\Lab\IF da settembre 2013\131023_rabbitAPC+mouseTNKS_wound_2nd exp - 60 min STRANI\300dpi 4cm\TNKS verde\1-DMSO 0 min_ProjMax001_ch01.tif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48220" y="303750"/>
            <a:ext cx="1438275" cy="14382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57" name="Picture 61" descr="F:\Nuova cartella\Lab\IF da settembre 2013\131023_rabbitAPC+mouseTNKS_wound_2nd exp - 60 min STRANI\300dpi 4cm\TNKS verde\2-JNJ272 0 min_ProjMax001_ch01.tif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48220" y="3466808"/>
            <a:ext cx="1438275" cy="14382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58" name="Picture 62" descr="F:\Nuova cartella\Lab\IF da settembre 2013\131023_rabbitAPC+mouseTNKS_wound_2nd exp - 60 min STRANI\300dpi 4cm\TNKS verde\3-JNJ928 0 min_ProjMax001_ch01.tif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48220" y="6619728"/>
            <a:ext cx="1438275" cy="14382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59" name="Picture 63" descr="F:\Nuova cartella\Lab\IF da settembre 2013\131023_rabbitAPC+mouseTNKS_wound_2nd exp - 60 min STRANI\300dpi 4cm\TNKS verde\4-DMSO 15 min_ProjMax001_ch01.tif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2748220" y="1754089"/>
            <a:ext cx="1438275" cy="14382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60" name="Picture 64" descr="F:\Nuova cartella\Lab\IF da settembre 2013\131023_rabbitAPC+mouseTNKS_wound_2nd exp - 60 min STRANI\300dpi 4cm\TNKS verde\5-JNJ272 15 min_ProjMax001_ch01.tif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0800000">
            <a:off x="2748220" y="4915975"/>
            <a:ext cx="1438275" cy="14382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61" name="Picture 65" descr="F:\Nuova cartella\Lab\IF da settembre 2013\131023_rabbitAPC+mouseTNKS_wound_2nd exp - 60 min STRANI\300dpi 4cm\TNKS verde\6-JNJ928 15 min_ProjMax001_ch01.tif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48220" y="8065168"/>
            <a:ext cx="1438275" cy="14382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62" name="Picture 66" descr="F:\Nuova cartella\Lab\IF da settembre 2013\131023_rabbitAPC+mouseTNKS_wound_2nd exp - 60 min STRANI\300dpi 4cm\Merge\1-DMSO 0 min_ProjMax001_ch02.tif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95970" y="303749"/>
            <a:ext cx="1438275" cy="14382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63" name="Picture 67" descr="F:\Nuova cartella\Lab\IF da settembre 2013\131023_rabbitAPC+mouseTNKS_wound_2nd exp - 60 min STRANI\300dpi 4cm\Merge\4-DMSO 15 min_ProjMax001_ch01.tif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4195970" y="1757264"/>
            <a:ext cx="1438275" cy="14382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7" name="Text Box 26"/>
          <p:cNvSpPr txBox="1">
            <a:spLocks noChangeArrowheads="1"/>
          </p:cNvSpPr>
          <p:nvPr/>
        </p:nvSpPr>
        <p:spPr bwMode="auto">
          <a:xfrm rot="16200000">
            <a:off x="773129" y="4058233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Untreated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 Box 26"/>
          <p:cNvSpPr txBox="1">
            <a:spLocks noChangeArrowheads="1"/>
          </p:cNvSpPr>
          <p:nvPr/>
        </p:nvSpPr>
        <p:spPr bwMode="auto">
          <a:xfrm rot="16200000">
            <a:off x="589185" y="5510172"/>
            <a:ext cx="1125125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HGF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165" name="Picture 69" descr="F:\Nuova cartella\Lab\IF da settembre 2013\131023_rabbitAPC+mouseTNKS_wound_2nd exp - 60 min STRANI\300dpi 4cm\Merge\2-JNJ272 0 min_ProjMax001_ch01.tif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95970" y="3466808"/>
            <a:ext cx="1438275" cy="14382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66" name="Picture 70" descr="F:\Nuova cartella\Lab\IF da settembre 2013\131023_rabbitAPC+mouseTNKS_wound_2nd exp - 60 min STRANI\300dpi 4cm\Merge\5-JNJ272 15 min_ProjMax001_ch01.tif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0800000">
            <a:off x="4195970" y="4915974"/>
            <a:ext cx="1438275" cy="14382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5" name="Text Box 26"/>
          <p:cNvSpPr txBox="1">
            <a:spLocks noChangeArrowheads="1"/>
          </p:cNvSpPr>
          <p:nvPr/>
        </p:nvSpPr>
        <p:spPr bwMode="auto">
          <a:xfrm rot="16200000">
            <a:off x="773128" y="7207179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Untreated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 Box 26"/>
          <p:cNvSpPr txBox="1">
            <a:spLocks noChangeArrowheads="1"/>
          </p:cNvSpPr>
          <p:nvPr/>
        </p:nvSpPr>
        <p:spPr bwMode="auto">
          <a:xfrm rot="16200000">
            <a:off x="589185" y="8659118"/>
            <a:ext cx="1125125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HGF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167" name="Picture 71" descr="F:\Nuova cartella\Lab\IF da settembre 2013\131023_rabbitAPC+mouseTNKS_wound_2nd exp - 60 min STRANI\300dpi 4cm\Merge\3-JNJ928 0 min_ProjMax001_ch01.tif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95970" y="6619727"/>
            <a:ext cx="1438275" cy="14382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68" name="Picture 72" descr="F:\Nuova cartella\Lab\IF da settembre 2013\131023_rabbitAPC+mouseTNKS_wound_2nd exp - 60 min STRANI\300dpi 4cm\Merge\6-JNJ928 15 min_ProjMax001_ch01.tif"/>
          <p:cNvPicPr>
            <a:picLocks noChangeAspect="1" noChangeArrowheads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95970" y="8065168"/>
            <a:ext cx="1438275" cy="14382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43" name="Connettore 1 35"/>
          <p:cNvCxnSpPr/>
          <p:nvPr/>
        </p:nvCxnSpPr>
        <p:spPr>
          <a:xfrm>
            <a:off x="1348855" y="1673905"/>
            <a:ext cx="9144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 Box 26"/>
          <p:cNvSpPr txBox="1">
            <a:spLocks noChangeArrowheads="1"/>
          </p:cNvSpPr>
          <p:nvPr/>
        </p:nvSpPr>
        <p:spPr bwMode="auto">
          <a:xfrm>
            <a:off x="4345409" y="77981"/>
            <a:ext cx="1295943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uclei</a:t>
            </a:r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it-IT" sz="9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PC</a:t>
            </a:r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it-IT" sz="900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NKS</a:t>
            </a:r>
            <a:endParaRPr lang="en-US" altLang="it-IT" sz="900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 Box 26"/>
          <p:cNvSpPr txBox="1">
            <a:spLocks noChangeArrowheads="1"/>
          </p:cNvSpPr>
          <p:nvPr/>
        </p:nvSpPr>
        <p:spPr bwMode="auto">
          <a:xfrm>
            <a:off x="1631420" y="3242810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APC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 Box 26"/>
          <p:cNvSpPr txBox="1">
            <a:spLocks noChangeArrowheads="1"/>
          </p:cNvSpPr>
          <p:nvPr/>
        </p:nvSpPr>
        <p:spPr bwMode="auto">
          <a:xfrm>
            <a:off x="3084935" y="3242810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TNKS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 Box 26"/>
          <p:cNvSpPr txBox="1">
            <a:spLocks noChangeArrowheads="1"/>
          </p:cNvSpPr>
          <p:nvPr/>
        </p:nvSpPr>
        <p:spPr bwMode="auto">
          <a:xfrm>
            <a:off x="4349230" y="3242810"/>
            <a:ext cx="1295943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uclei</a:t>
            </a:r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it-IT" sz="9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PC</a:t>
            </a:r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it-IT" sz="900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NKS</a:t>
            </a:r>
            <a:endParaRPr lang="en-US" altLang="it-IT" sz="900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 Box 26"/>
          <p:cNvSpPr txBox="1">
            <a:spLocks noChangeArrowheads="1"/>
          </p:cNvSpPr>
          <p:nvPr/>
        </p:nvSpPr>
        <p:spPr bwMode="auto">
          <a:xfrm>
            <a:off x="1628800" y="6393160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APC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 Box 26"/>
          <p:cNvSpPr txBox="1">
            <a:spLocks noChangeArrowheads="1"/>
          </p:cNvSpPr>
          <p:nvPr/>
        </p:nvSpPr>
        <p:spPr bwMode="auto">
          <a:xfrm>
            <a:off x="3082315" y="6393160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TNKS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 Box 26"/>
          <p:cNvSpPr txBox="1">
            <a:spLocks noChangeArrowheads="1"/>
          </p:cNvSpPr>
          <p:nvPr/>
        </p:nvSpPr>
        <p:spPr bwMode="auto">
          <a:xfrm>
            <a:off x="4346610" y="6393160"/>
            <a:ext cx="1295943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uclei</a:t>
            </a:r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it-IT" sz="9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PC</a:t>
            </a:r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it-IT" sz="900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NKS</a:t>
            </a:r>
            <a:endParaRPr lang="en-US" altLang="it-IT" sz="900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45" name="Picture 21" descr="F:\LAB\Lab\IF da settembre 2013\131023_rabbitAPC+mouseTNKS_wound_2nd exp - 60 min STRANI\300dpi 4cm\Merge\Insets\3 cm\4-DMSO 15 min_ProjMax001_ch00_CROP.tif"/>
          <p:cNvPicPr>
            <a:picLocks noChangeAspect="1" noChangeArrowheads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1295431" y="1760552"/>
            <a:ext cx="523875" cy="53975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Rectangle 3"/>
          <p:cNvSpPr/>
          <p:nvPr/>
        </p:nvSpPr>
        <p:spPr>
          <a:xfrm>
            <a:off x="1878128" y="2340523"/>
            <a:ext cx="323850" cy="319821"/>
          </a:xfrm>
          <a:prstGeom prst="rect">
            <a:avLst/>
          </a:prstGeom>
          <a:noFill/>
          <a:ln w="952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69" name="Rectangle 68"/>
          <p:cNvSpPr/>
          <p:nvPr/>
        </p:nvSpPr>
        <p:spPr>
          <a:xfrm>
            <a:off x="3317475" y="2345078"/>
            <a:ext cx="323850" cy="319821"/>
          </a:xfrm>
          <a:prstGeom prst="rect">
            <a:avLst/>
          </a:prstGeom>
          <a:noFill/>
          <a:ln w="952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2" name="Rectangle 71"/>
          <p:cNvSpPr/>
          <p:nvPr/>
        </p:nvSpPr>
        <p:spPr>
          <a:xfrm>
            <a:off x="4753182" y="2351756"/>
            <a:ext cx="323850" cy="319821"/>
          </a:xfrm>
          <a:prstGeom prst="rect">
            <a:avLst/>
          </a:prstGeom>
          <a:noFill/>
          <a:ln w="952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1050" name="Picture 26" descr="F:\LAB\Lab\IF da settembre 2013\131023_rabbitAPC+mouseTNKS_wound_2nd exp - 60 min STRANI\300dpi 4cm\Merge\Insets\3 cm\4-DMSO 15 min_ProjMax001_ch01_CROP.tif"/>
          <p:cNvPicPr>
            <a:picLocks noChangeAspect="1" noChangeArrowheads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2753925" y="1757645"/>
            <a:ext cx="523875" cy="53975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51" name="Picture 27" descr="F:\LAB\Lab\IF da settembre 2013\131023_rabbitAPC+mouseTNKS_wound_2nd exp - 60 min STRANI\300dpi 4cm\Merge\Insets\3 cm\4-DMSO 15 min_ProjMax001_ch01_MERGE CROP.tif"/>
          <p:cNvPicPr>
            <a:picLocks noChangeAspect="1" noChangeArrowheads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4195970" y="1760552"/>
            <a:ext cx="523875" cy="53975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52" name="Picture 28" descr="F:\LAB\Lab\IF da settembre 2013\131023_rabbitAPC+mouseTNKS_wound_2nd exp - 60 min STRANI\300dpi 4cm\Merge\Insets\3 cm\5-JNJ272 15 min_ProjMax001_ch00_CROP.tif"/>
          <p:cNvPicPr>
            <a:picLocks noChangeAspect="1" noChangeArrowheads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0800000">
            <a:off x="1295430" y="4921691"/>
            <a:ext cx="523875" cy="53975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8" name="Rectangle 77"/>
          <p:cNvSpPr/>
          <p:nvPr/>
        </p:nvSpPr>
        <p:spPr>
          <a:xfrm>
            <a:off x="1740955" y="5746837"/>
            <a:ext cx="323850" cy="319821"/>
          </a:xfrm>
          <a:prstGeom prst="rect">
            <a:avLst/>
          </a:prstGeom>
          <a:noFill/>
          <a:ln w="952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9" name="Rectangle 78"/>
          <p:cNvSpPr/>
          <p:nvPr/>
        </p:nvSpPr>
        <p:spPr>
          <a:xfrm>
            <a:off x="3187230" y="5750110"/>
            <a:ext cx="323850" cy="319821"/>
          </a:xfrm>
          <a:prstGeom prst="rect">
            <a:avLst/>
          </a:prstGeom>
          <a:noFill/>
          <a:ln w="952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80" name="Rectangle 79"/>
          <p:cNvSpPr/>
          <p:nvPr/>
        </p:nvSpPr>
        <p:spPr>
          <a:xfrm>
            <a:off x="4669529" y="5755104"/>
            <a:ext cx="323850" cy="319821"/>
          </a:xfrm>
          <a:prstGeom prst="rect">
            <a:avLst/>
          </a:prstGeom>
          <a:noFill/>
          <a:ln w="952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1055" name="Picture 31" descr="F:\LAB\Lab\IF da settembre 2013\131023_rabbitAPC+mouseTNKS_wound_2nd exp - 60 min STRANI\300dpi 4cm\Merge\Insets\3 cm\5-JNJ272 15 min_ProjMax001_ch01_CROP.tif"/>
          <p:cNvPicPr>
            <a:picLocks noChangeAspect="1" noChangeArrowheads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0800000">
            <a:off x="2754570" y="4921691"/>
            <a:ext cx="523875" cy="53975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56" name="Picture 32" descr="F:\LAB\Lab\IF da settembre 2013\131023_rabbitAPC+mouseTNKS_wound_2nd exp - 60 min STRANI\300dpi 4cm\Merge\Insets\3 cm\5-JNJ272 15 min_ProjMax001_ch01_MERGE CROP.tif"/>
          <p:cNvPicPr>
            <a:picLocks noChangeAspect="1" noChangeArrowheads="1"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0800000">
            <a:off x="4208670" y="4923607"/>
            <a:ext cx="523875" cy="53975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5" name="Rectangle 84"/>
          <p:cNvSpPr/>
          <p:nvPr/>
        </p:nvSpPr>
        <p:spPr>
          <a:xfrm>
            <a:off x="1728255" y="9177186"/>
            <a:ext cx="323850" cy="319821"/>
          </a:xfrm>
          <a:prstGeom prst="rect">
            <a:avLst/>
          </a:prstGeom>
          <a:noFill/>
          <a:ln w="952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87" name="Rectangle 86"/>
          <p:cNvSpPr/>
          <p:nvPr/>
        </p:nvSpPr>
        <p:spPr>
          <a:xfrm>
            <a:off x="3187230" y="9176025"/>
            <a:ext cx="323850" cy="319821"/>
          </a:xfrm>
          <a:prstGeom prst="rect">
            <a:avLst/>
          </a:prstGeom>
          <a:noFill/>
          <a:ln w="952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88" name="Rectangle 87"/>
          <p:cNvSpPr/>
          <p:nvPr/>
        </p:nvSpPr>
        <p:spPr>
          <a:xfrm>
            <a:off x="4650479" y="9168514"/>
            <a:ext cx="323850" cy="319821"/>
          </a:xfrm>
          <a:prstGeom prst="rect">
            <a:avLst/>
          </a:prstGeom>
          <a:noFill/>
          <a:ln w="952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1058" name="Picture 34" descr="F:\LAB\Lab\IF da settembre 2013\131023_rabbitAPC+mouseTNKS_wound_2nd exp - 60 min STRANI\300dpi 4cm\Merge\Insets\3 cm\6-JNJ928 15 min_ProjMax001_ch00_CROP.tif"/>
          <p:cNvPicPr>
            <a:picLocks noChangeAspect="1" noChangeArrowheads="1"/>
          </p:cNvPicPr>
          <p:nvPr/>
        </p:nvPicPr>
        <p:blipFill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95431" y="8073245"/>
            <a:ext cx="523875" cy="53975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59" name="Picture 35" descr="F:\LAB\Lab\IF da settembre 2013\131023_rabbitAPC+mouseTNKS_wound_2nd exp - 60 min STRANI\300dpi 4cm\Merge\Insets\3 cm\6-JNJ928 15 min_ProjMax001_ch01_CROP.tif"/>
          <p:cNvPicPr>
            <a:picLocks noChangeAspect="1" noChangeArrowheads="1"/>
          </p:cNvPicPr>
          <p:nvPr/>
        </p:nvPicPr>
        <p:blipFill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57549" y="8073245"/>
            <a:ext cx="523875" cy="53975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60" name="Picture 36" descr="F:\LAB\Lab\IF da settembre 2013\131023_rabbitAPC+mouseTNKS_wound_2nd exp - 60 min STRANI\300dpi 4cm\Merge\Insets\3 cm\6-JNJ928 15 min_ProjMax001_ch01_MERGE CROP.tif"/>
          <p:cNvPicPr>
            <a:picLocks noChangeAspect="1" noChangeArrowheads="1"/>
          </p:cNvPicPr>
          <p:nvPr/>
        </p:nvPicPr>
        <p:blipFill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02319" y="8070703"/>
            <a:ext cx="523875" cy="53975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61" name="Picture 37" descr="F:\LAB\Lab\IF da settembre 2013\131023_rabbitAPC+mouseTNKS_wound_2nd exp - 60 min STRANI\300dpi 4cm\Merge\Insets\3 cm\1-DMSO 0 min_ProjMax001_ch00_CROP.tif"/>
          <p:cNvPicPr>
            <a:picLocks noChangeAspect="1" noChangeArrowheads="1"/>
          </p:cNvPicPr>
          <p:nvPr/>
        </p:nvPicPr>
        <p:blipFill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95431" y="303749"/>
            <a:ext cx="523875" cy="53975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4" name="Rectangle 93"/>
          <p:cNvSpPr/>
          <p:nvPr/>
        </p:nvSpPr>
        <p:spPr>
          <a:xfrm>
            <a:off x="1557368" y="1075702"/>
            <a:ext cx="323850" cy="319821"/>
          </a:xfrm>
          <a:prstGeom prst="rect">
            <a:avLst/>
          </a:prstGeom>
          <a:noFill/>
          <a:ln w="952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96" name="Rectangle 95"/>
          <p:cNvSpPr/>
          <p:nvPr/>
        </p:nvSpPr>
        <p:spPr>
          <a:xfrm>
            <a:off x="3015862" y="1099844"/>
            <a:ext cx="323850" cy="319821"/>
          </a:xfrm>
          <a:prstGeom prst="rect">
            <a:avLst/>
          </a:prstGeom>
          <a:noFill/>
          <a:ln w="952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99" name="Rectangle 98"/>
          <p:cNvSpPr/>
          <p:nvPr/>
        </p:nvSpPr>
        <p:spPr>
          <a:xfrm>
            <a:off x="4488554" y="1078156"/>
            <a:ext cx="323850" cy="319821"/>
          </a:xfrm>
          <a:prstGeom prst="rect">
            <a:avLst/>
          </a:prstGeom>
          <a:noFill/>
          <a:ln w="952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1065" name="Picture 41" descr="F:\LAB\Lab\IF da settembre 2013\131023_rabbitAPC+mouseTNKS_wound_2nd exp - 60 min STRANI\300dpi 4cm\Merge\Insets\3 cm\1-DMSO 0 min_ProjMax001_ch01_CROP.tif"/>
          <p:cNvPicPr>
            <a:picLocks noChangeAspect="1" noChangeArrowheads="1"/>
          </p:cNvPicPr>
          <p:nvPr/>
        </p:nvPicPr>
        <p:blipFill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57549" y="303749"/>
            <a:ext cx="523875" cy="53975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66" name="Picture 42" descr="F:\LAB\Lab\IF da settembre 2013\131023_rabbitAPC+mouseTNKS_wound_2nd exp - 60 min STRANI\300dpi 4cm\Merge\Insets\3 cm\1-DMSO 0 min_ProjMax001_ch02_MERGE CROP.tif"/>
          <p:cNvPicPr>
            <a:picLocks noChangeAspect="1" noChangeArrowheads="1"/>
          </p:cNvPicPr>
          <p:nvPr/>
        </p:nvPicPr>
        <p:blipFill>
          <a:blip r:embed="rId3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02319" y="303749"/>
            <a:ext cx="523875" cy="53975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3" name="Rectangle 102"/>
          <p:cNvSpPr/>
          <p:nvPr/>
        </p:nvSpPr>
        <p:spPr>
          <a:xfrm>
            <a:off x="4812404" y="4229061"/>
            <a:ext cx="323850" cy="319821"/>
          </a:xfrm>
          <a:prstGeom prst="rect">
            <a:avLst/>
          </a:prstGeom>
          <a:noFill/>
          <a:ln w="952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04" name="Rectangle 103"/>
          <p:cNvSpPr/>
          <p:nvPr/>
        </p:nvSpPr>
        <p:spPr>
          <a:xfrm>
            <a:off x="3354952" y="4241027"/>
            <a:ext cx="323850" cy="319821"/>
          </a:xfrm>
          <a:prstGeom prst="rect">
            <a:avLst/>
          </a:prstGeom>
          <a:noFill/>
          <a:ln w="952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05" name="Rectangle 104"/>
          <p:cNvSpPr/>
          <p:nvPr/>
        </p:nvSpPr>
        <p:spPr>
          <a:xfrm>
            <a:off x="1890180" y="4217095"/>
            <a:ext cx="323850" cy="319821"/>
          </a:xfrm>
          <a:prstGeom prst="rect">
            <a:avLst/>
          </a:prstGeom>
          <a:noFill/>
          <a:ln w="952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1068" name="Picture 44" descr="F:\LAB\Lab\IF da settembre 2013\131023_rabbitAPC+mouseTNKS_wound_2nd exp - 60 min STRANI\300dpi 4cm\Merge\Insets\3 cm\2-JNJ272 0 min_ProjMax001_ch00_CROP.tif"/>
          <p:cNvPicPr>
            <a:picLocks noChangeAspect="1" noChangeArrowheads="1"/>
          </p:cNvPicPr>
          <p:nvPr/>
        </p:nvPicPr>
        <p:blipFill>
          <a:blip r:embed="rId3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02826" y="3474428"/>
            <a:ext cx="523875" cy="53975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69" name="Picture 45" descr="F:\LAB\Lab\IF da settembre 2013\131023_rabbitAPC+mouseTNKS_wound_2nd exp - 60 min STRANI\300dpi 4cm\Merge\Insets\3 cm\2-JNJ272 0 min_ProjMax001_ch01_CROP.tif"/>
          <p:cNvPicPr>
            <a:picLocks noChangeAspect="1" noChangeArrowheads="1"/>
          </p:cNvPicPr>
          <p:nvPr/>
        </p:nvPicPr>
        <p:blipFill>
          <a:blip r:embed="rId3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54570" y="3466808"/>
            <a:ext cx="523875" cy="53975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70" name="Picture 46" descr="F:\LAB\Lab\IF da settembre 2013\131023_rabbitAPC+mouseTNKS_wound_2nd exp - 60 min STRANI\300dpi 4cm\Merge\Insets\3 cm\2-JNJ272 0 min_ProjMax001_ch01_MERGE CROP.tif"/>
          <p:cNvPicPr>
            <a:picLocks noChangeAspect="1" noChangeArrowheads="1"/>
          </p:cNvPicPr>
          <p:nvPr/>
        </p:nvPicPr>
        <p:blipFill>
          <a:blip r:embed="rId3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09356" y="3465646"/>
            <a:ext cx="523875" cy="53975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0" name="Rectangle 109"/>
          <p:cNvSpPr/>
          <p:nvPr/>
        </p:nvSpPr>
        <p:spPr>
          <a:xfrm>
            <a:off x="4907861" y="7481494"/>
            <a:ext cx="323850" cy="319821"/>
          </a:xfrm>
          <a:prstGeom prst="rect">
            <a:avLst/>
          </a:prstGeom>
          <a:noFill/>
          <a:ln w="952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11" name="Rectangle 110"/>
          <p:cNvSpPr/>
          <p:nvPr/>
        </p:nvSpPr>
        <p:spPr>
          <a:xfrm>
            <a:off x="3479400" y="7481494"/>
            <a:ext cx="323850" cy="319821"/>
          </a:xfrm>
          <a:prstGeom prst="rect">
            <a:avLst/>
          </a:prstGeom>
          <a:noFill/>
          <a:ln w="952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12" name="Rectangle 111"/>
          <p:cNvSpPr/>
          <p:nvPr/>
        </p:nvSpPr>
        <p:spPr>
          <a:xfrm>
            <a:off x="2039830" y="7485641"/>
            <a:ext cx="323850" cy="319821"/>
          </a:xfrm>
          <a:prstGeom prst="rect">
            <a:avLst/>
          </a:prstGeom>
          <a:noFill/>
          <a:ln w="952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1072" name="Picture 48" descr="F:\LAB\Lab\IF da settembre 2013\131023_rabbitAPC+mouseTNKS_wound_2nd exp - 60 min STRANI\300dpi 4cm\Merge\Insets\3 cm\3-JNJ928 0 min_ProjMax001_ch00_CROP.tif"/>
          <p:cNvPicPr>
            <a:picLocks noChangeAspect="1" noChangeArrowheads="1"/>
          </p:cNvPicPr>
          <p:nvPr/>
        </p:nvPicPr>
        <p:blipFill>
          <a:blip r:embed="rId3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98062" y="6624491"/>
            <a:ext cx="523875" cy="53975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73" name="Picture 49" descr="F:\LAB\Lab\IF da settembre 2013\131023_rabbitAPC+mouseTNKS_wound_2nd exp - 60 min STRANI\300dpi 4cm\Merge\Insets\3 cm\3-JNJ928 0 min_ProjMax001_ch01_CROP.tif"/>
          <p:cNvPicPr>
            <a:picLocks noChangeAspect="1" noChangeArrowheads="1"/>
          </p:cNvPicPr>
          <p:nvPr/>
        </p:nvPicPr>
        <p:blipFill>
          <a:blip r:embed="rId3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52786" y="6624491"/>
            <a:ext cx="523875" cy="53975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74" name="Picture 50" descr="F:\LAB\Lab\IF da settembre 2013\131023_rabbitAPC+mouseTNKS_wound_2nd exp - 60 min STRANI\300dpi 4cm\Merge\Insets\3 cm\3-JNJ928 0 min_ProjMax001_ch01_MERGE_CROP.tif"/>
          <p:cNvPicPr>
            <a:picLocks noChangeAspect="1" noChangeArrowheads="1"/>
          </p:cNvPicPr>
          <p:nvPr/>
        </p:nvPicPr>
        <p:blipFill>
          <a:blip r:embed="rId3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97555" y="6619728"/>
            <a:ext cx="523875" cy="53975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81" name="Connettore 1 35"/>
          <p:cNvCxnSpPr/>
          <p:nvPr/>
        </p:nvCxnSpPr>
        <p:spPr>
          <a:xfrm>
            <a:off x="1339718" y="376779"/>
            <a:ext cx="18288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TextBox 81"/>
          <p:cNvSpPr txBox="1"/>
          <p:nvPr/>
        </p:nvSpPr>
        <p:spPr>
          <a:xfrm>
            <a:off x="4329100" y="9640916"/>
            <a:ext cx="24497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upo et al., 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Additional File </a:t>
            </a:r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9: 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8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819884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35"/>
          <p:cNvSpPr txBox="1"/>
          <p:nvPr/>
        </p:nvSpPr>
        <p:spPr>
          <a:xfrm>
            <a:off x="593684" y="415332"/>
            <a:ext cx="5535615" cy="1708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</a:t>
            </a:r>
            <a:r>
              <a:rPr lang="it-IT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9: </a:t>
            </a:r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it-IT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8. 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NKS is recruited to cortical areas in migrating 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cells</a:t>
            </a:r>
            <a:endParaRPr lang="en-US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endParaRPr lang="en-US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erum-starved A549 cells, either left untreated or incubated with TNKS inhibitors (10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for 24h, were scratched with a pipette tip prior to treatment with HGF (HGF, 50 ng/ml) for 15 min. Cells were then fixed and stained with anti‑APC and anti-TNKS antibodies. Insets show higher magnification fields. Shown here is one illustrative experiment  out of two performed. Scale bar, 7 </a:t>
            </a:r>
            <a:r>
              <a:rPr lang="en-US" sz="1000" dirty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.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4459492" y="9640916"/>
            <a:ext cx="24497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upo et al., 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Additional File </a:t>
            </a:r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9: 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8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964282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6699</TotalTime>
  <Words>131</Words>
  <Application>Microsoft Office PowerPoint</Application>
  <PresentationFormat>A4 Paper (210x297 mm)</PresentationFormat>
  <Paragraphs>24</Paragraphs>
  <Slides>2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rbara Lupo</dc:creator>
  <cp:lastModifiedBy>ltrusolino</cp:lastModifiedBy>
  <cp:revision>575</cp:revision>
  <cp:lastPrinted>2015-12-02T11:12:15Z</cp:lastPrinted>
  <dcterms:created xsi:type="dcterms:W3CDTF">2006-08-16T00:00:00Z</dcterms:created>
  <dcterms:modified xsi:type="dcterms:W3CDTF">2015-12-14T10:20:55Z</dcterms:modified>
</cp:coreProperties>
</file>